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4" r:id="rId4"/>
    <p:sldId id="265" r:id="rId5"/>
    <p:sldId id="266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CA205C5-AFF6-4012-A7EF-CDC62B150E55}" v="21" dt="2026-01-14T00:54:17.7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1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young jung" userId="2cd33e9aba789339" providerId="LiveId" clId="{AA236221-2BE9-4F5F-A09F-FD46EB557B01}"/>
    <pc:docChg chg="undo custSel addSld delSld modSld sldOrd">
      <pc:chgData name="juyoung jung" userId="2cd33e9aba789339" providerId="LiveId" clId="{AA236221-2BE9-4F5F-A09F-FD46EB557B01}" dt="2026-01-14T00:55:14.842" v="382" actId="20577"/>
      <pc:docMkLst>
        <pc:docMk/>
      </pc:docMkLst>
      <pc:sldChg chg="addSp delSp modSp mod">
        <pc:chgData name="juyoung jung" userId="2cd33e9aba789339" providerId="LiveId" clId="{AA236221-2BE9-4F5F-A09F-FD46EB557B01}" dt="2026-01-14T00:51:46.265" v="318" actId="20577"/>
        <pc:sldMkLst>
          <pc:docMk/>
          <pc:sldMk cId="3586287062" sldId="257"/>
        </pc:sldMkLst>
        <pc:spChg chg="add del mod">
          <ac:chgData name="juyoung jung" userId="2cd33e9aba789339" providerId="LiveId" clId="{AA236221-2BE9-4F5F-A09F-FD46EB557B01}" dt="2026-01-14T00:41:23.958" v="168"/>
          <ac:spMkLst>
            <pc:docMk/>
            <pc:sldMk cId="3586287062" sldId="257"/>
            <ac:spMk id="3" creationId="{DD3E39D1-4C18-600C-EB11-5EE96F531BC7}"/>
          </ac:spMkLst>
        </pc:spChg>
        <pc:spChg chg="mod">
          <ac:chgData name="juyoung jung" userId="2cd33e9aba789339" providerId="LiveId" clId="{AA236221-2BE9-4F5F-A09F-FD46EB557B01}" dt="2026-01-14T00:51:46.265" v="318" actId="20577"/>
          <ac:spMkLst>
            <pc:docMk/>
            <pc:sldMk cId="3586287062" sldId="257"/>
            <ac:spMk id="5" creationId="{00000000-0000-0000-0000-000000000000}"/>
          </ac:spMkLst>
        </pc:spChg>
        <pc:picChg chg="del mod">
          <ac:chgData name="juyoung jung" userId="2cd33e9aba789339" providerId="LiveId" clId="{AA236221-2BE9-4F5F-A09F-FD46EB557B01}" dt="2026-01-14T00:41:14.866" v="167" actId="21"/>
          <ac:picMkLst>
            <pc:docMk/>
            <pc:sldMk cId="3586287062" sldId="257"/>
            <ac:picMk id="4" creationId="{00000000-0000-0000-0000-000000000000}"/>
          </ac:picMkLst>
        </pc:picChg>
        <pc:picChg chg="add mod">
          <ac:chgData name="juyoung jung" userId="2cd33e9aba789339" providerId="LiveId" clId="{AA236221-2BE9-4F5F-A09F-FD46EB557B01}" dt="2026-01-14T00:41:44.553" v="177" actId="14100"/>
          <ac:picMkLst>
            <pc:docMk/>
            <pc:sldMk cId="3586287062" sldId="257"/>
            <ac:picMk id="8" creationId="{3768716D-B2F1-0E9C-21DA-C561F1802626}"/>
          </ac:picMkLst>
        </pc:picChg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2730808792" sldId="258"/>
        </pc:sldMkLst>
      </pc:sldChg>
      <pc:sldChg chg="modSp add mod">
        <pc:chgData name="juyoung jung" userId="2cd33e9aba789339" providerId="LiveId" clId="{AA236221-2BE9-4F5F-A09F-FD46EB557B01}" dt="2026-01-14T00:51:49.834" v="320" actId="20577"/>
        <pc:sldMkLst>
          <pc:docMk/>
          <pc:sldMk cId="3761748432" sldId="258"/>
        </pc:sldMkLst>
        <pc:spChg chg="mod">
          <ac:chgData name="juyoung jung" userId="2cd33e9aba789339" providerId="LiveId" clId="{AA236221-2BE9-4F5F-A09F-FD46EB557B01}" dt="2026-01-14T00:51:49.834" v="320" actId="20577"/>
          <ac:spMkLst>
            <pc:docMk/>
            <pc:sldMk cId="3761748432" sldId="258"/>
            <ac:spMk id="5" creationId="{DD6B9412-378D-BA20-9915-1F7FDB2B396D}"/>
          </ac:spMkLst>
        </pc:spChg>
        <pc:spChg chg="mod">
          <ac:chgData name="juyoung jung" userId="2cd33e9aba789339" providerId="LiveId" clId="{AA236221-2BE9-4F5F-A09F-FD46EB557B01}" dt="2026-01-14T00:42:38.944" v="252" actId="20577"/>
          <ac:spMkLst>
            <pc:docMk/>
            <pc:sldMk cId="3761748432" sldId="258"/>
            <ac:spMk id="6" creationId="{5960B0CE-E762-07DA-FB0D-45AE865F6E01}"/>
          </ac:spMkLst>
        </pc:spChg>
        <pc:picChg chg="mod">
          <ac:chgData name="juyoung jung" userId="2cd33e9aba789339" providerId="LiveId" clId="{AA236221-2BE9-4F5F-A09F-FD46EB557B01}" dt="2026-01-14T00:42:54.804" v="258" actId="14826"/>
          <ac:picMkLst>
            <pc:docMk/>
            <pc:sldMk cId="3761748432" sldId="258"/>
            <ac:picMk id="8" creationId="{3541C844-66CB-C576-1C2F-0BE227F8B28D}"/>
          </ac:picMkLst>
        </pc:picChg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649458596" sldId="259"/>
        </pc:sldMkLst>
      </pc:sldChg>
      <pc:sldChg chg="modSp add mod">
        <pc:chgData name="juyoung jung" userId="2cd33e9aba789339" providerId="LiveId" clId="{AA236221-2BE9-4F5F-A09F-FD46EB557B01}" dt="2026-01-14T00:51:58.757" v="325" actId="20577"/>
        <pc:sldMkLst>
          <pc:docMk/>
          <pc:sldMk cId="3845637068" sldId="259"/>
        </pc:sldMkLst>
        <pc:spChg chg="mod">
          <ac:chgData name="juyoung jung" userId="2cd33e9aba789339" providerId="LiveId" clId="{AA236221-2BE9-4F5F-A09F-FD46EB557B01}" dt="2026-01-14T00:51:58.757" v="325" actId="20577"/>
          <ac:spMkLst>
            <pc:docMk/>
            <pc:sldMk cId="3845637068" sldId="259"/>
            <ac:spMk id="5" creationId="{C8210C0E-6DD6-F569-8F14-E0CEDAFB67CC}"/>
          </ac:spMkLst>
        </pc:spChg>
        <pc:spChg chg="mod">
          <ac:chgData name="juyoung jung" userId="2cd33e9aba789339" providerId="LiveId" clId="{AA236221-2BE9-4F5F-A09F-FD46EB557B01}" dt="2026-01-14T00:44:54.142" v="292" actId="20577"/>
          <ac:spMkLst>
            <pc:docMk/>
            <pc:sldMk cId="3845637068" sldId="259"/>
            <ac:spMk id="6" creationId="{FDB595E4-DC5B-D2DA-8FBE-31ABC283ECD7}"/>
          </ac:spMkLst>
        </pc:spChg>
      </pc:sldChg>
      <pc:sldChg chg="new del">
        <pc:chgData name="juyoung jung" userId="2cd33e9aba789339" providerId="LiveId" clId="{AA236221-2BE9-4F5F-A09F-FD46EB557B01}" dt="2026-01-14T00:43:42.889" v="269" actId="680"/>
        <pc:sldMkLst>
          <pc:docMk/>
          <pc:sldMk cId="758507618" sldId="260"/>
        </pc:sldMkLst>
      </pc:sldChg>
      <pc:sldChg chg="del">
        <pc:chgData name="juyoung jung" userId="2cd33e9aba789339" providerId="LiveId" clId="{AA236221-2BE9-4F5F-A09F-FD46EB557B01}" dt="2026-01-14T00:42:25.168" v="249" actId="2696"/>
        <pc:sldMkLst>
          <pc:docMk/>
          <pc:sldMk cId="777955275" sldId="260"/>
        </pc:sldMkLst>
      </pc:sldChg>
      <pc:sldChg chg="modSp add mod ord">
        <pc:chgData name="juyoung jung" userId="2cd33e9aba789339" providerId="LiveId" clId="{AA236221-2BE9-4F5F-A09F-FD46EB557B01}" dt="2026-01-14T00:51:55.547" v="323" actId="14100"/>
        <pc:sldMkLst>
          <pc:docMk/>
          <pc:sldMk cId="2931836604" sldId="260"/>
        </pc:sldMkLst>
        <pc:spChg chg="mod">
          <ac:chgData name="juyoung jung" userId="2cd33e9aba789339" providerId="LiveId" clId="{AA236221-2BE9-4F5F-A09F-FD46EB557B01}" dt="2026-01-14T00:51:55.547" v="323" actId="14100"/>
          <ac:spMkLst>
            <pc:docMk/>
            <pc:sldMk cId="2931836604" sldId="260"/>
            <ac:spMk id="5" creationId="{3780BE0B-03D2-241F-91E8-4B15C600944C}"/>
          </ac:spMkLst>
        </pc:spChg>
        <pc:spChg chg="mod">
          <ac:chgData name="juyoung jung" userId="2cd33e9aba789339" providerId="LiveId" clId="{AA236221-2BE9-4F5F-A09F-FD46EB557B01}" dt="2026-01-14T00:44:33.846" v="281" actId="20577"/>
          <ac:spMkLst>
            <pc:docMk/>
            <pc:sldMk cId="2931836604" sldId="260"/>
            <ac:spMk id="6" creationId="{A6EDB326-B2E4-CDDC-F286-1F28F13410A6}"/>
          </ac:spMkLst>
        </pc:spChg>
      </pc:sldChg>
      <pc:sldChg chg="modSp add mod">
        <pc:chgData name="juyoung jung" userId="2cd33e9aba789339" providerId="LiveId" clId="{AA236221-2BE9-4F5F-A09F-FD46EB557B01}" dt="2026-01-14T00:52:02.726" v="327" actId="20577"/>
        <pc:sldMkLst>
          <pc:docMk/>
          <pc:sldMk cId="3292900752" sldId="261"/>
        </pc:sldMkLst>
        <pc:spChg chg="mod">
          <ac:chgData name="juyoung jung" userId="2cd33e9aba789339" providerId="LiveId" clId="{AA236221-2BE9-4F5F-A09F-FD46EB557B01}" dt="2026-01-14T00:52:02.726" v="327" actId="20577"/>
          <ac:spMkLst>
            <pc:docMk/>
            <pc:sldMk cId="3292900752" sldId="261"/>
            <ac:spMk id="5" creationId="{C4A3BC84-AAE2-7D27-B1B4-C1255EF3949E}"/>
          </ac:spMkLst>
        </pc:spChg>
        <pc:spChg chg="mod">
          <ac:chgData name="juyoung jung" userId="2cd33e9aba789339" providerId="LiveId" clId="{AA236221-2BE9-4F5F-A09F-FD46EB557B01}" dt="2026-01-14T00:45:22.433" v="298" actId="20577"/>
          <ac:spMkLst>
            <pc:docMk/>
            <pc:sldMk cId="3292900752" sldId="261"/>
            <ac:spMk id="6" creationId="{6A94608A-596A-A969-54C4-8C7BF4423D5F}"/>
          </ac:spMkLst>
        </pc:spChg>
        <pc:picChg chg="mod">
          <ac:chgData name="juyoung jung" userId="2cd33e9aba789339" providerId="LiveId" clId="{AA236221-2BE9-4F5F-A09F-FD46EB557B01}" dt="2026-01-14T00:45:32.997" v="299" actId="14826"/>
          <ac:picMkLst>
            <pc:docMk/>
            <pc:sldMk cId="3292900752" sldId="261"/>
            <ac:picMk id="8" creationId="{0BCA3891-1896-F941-4B62-9A677661E6F0}"/>
          </ac:picMkLst>
        </pc:picChg>
      </pc:sldChg>
      <pc:sldChg chg="modSp add mod">
        <pc:chgData name="juyoung jung" userId="2cd33e9aba789339" providerId="LiveId" clId="{AA236221-2BE9-4F5F-A09F-FD46EB557B01}" dt="2026-01-14T00:52:29.395" v="337" actId="20577"/>
        <pc:sldMkLst>
          <pc:docMk/>
          <pc:sldMk cId="2838625645" sldId="262"/>
        </pc:sldMkLst>
        <pc:spChg chg="mod">
          <ac:chgData name="juyoung jung" userId="2cd33e9aba789339" providerId="LiveId" clId="{AA236221-2BE9-4F5F-A09F-FD46EB557B01}" dt="2026-01-14T00:52:29.395" v="337" actId="20577"/>
          <ac:spMkLst>
            <pc:docMk/>
            <pc:sldMk cId="2838625645" sldId="262"/>
            <ac:spMk id="5" creationId="{70DEA4BF-45AA-F88C-A57C-1A0525E7F50C}"/>
          </ac:spMkLst>
        </pc:spChg>
        <pc:picChg chg="mod">
          <ac:chgData name="juyoung jung" userId="2cd33e9aba789339" providerId="LiveId" clId="{AA236221-2BE9-4F5F-A09F-FD46EB557B01}" dt="2026-01-14T00:50:00.736" v="308" actId="14826"/>
          <ac:picMkLst>
            <pc:docMk/>
            <pc:sldMk cId="2838625645" sldId="262"/>
            <ac:picMk id="8" creationId="{690DED58-EADD-6757-357A-1B6276E5D91F}"/>
          </ac:picMkLst>
        </pc:picChg>
      </pc:sldChg>
      <pc:sldChg chg="modSp add mod">
        <pc:chgData name="juyoung jung" userId="2cd33e9aba789339" providerId="LiveId" clId="{AA236221-2BE9-4F5F-A09F-FD46EB557B01}" dt="2026-01-14T00:52:31.891" v="338" actId="20577"/>
        <pc:sldMkLst>
          <pc:docMk/>
          <pc:sldMk cId="591835417" sldId="263"/>
        </pc:sldMkLst>
        <pc:spChg chg="mod">
          <ac:chgData name="juyoung jung" userId="2cd33e9aba789339" providerId="LiveId" clId="{AA236221-2BE9-4F5F-A09F-FD46EB557B01}" dt="2026-01-14T00:52:31.891" v="338" actId="20577"/>
          <ac:spMkLst>
            <pc:docMk/>
            <pc:sldMk cId="591835417" sldId="263"/>
            <ac:spMk id="5" creationId="{99D2FACF-43E7-D216-C0BE-354E016255E0}"/>
          </ac:spMkLst>
        </pc:spChg>
        <pc:picChg chg="mod">
          <ac:chgData name="juyoung jung" userId="2cd33e9aba789339" providerId="LiveId" clId="{AA236221-2BE9-4F5F-A09F-FD46EB557B01}" dt="2026-01-14T00:50:30.734" v="310" actId="14826"/>
          <ac:picMkLst>
            <pc:docMk/>
            <pc:sldMk cId="591835417" sldId="263"/>
            <ac:picMk id="8" creationId="{7A9D7A01-F48C-0FD2-8BF8-263CD956AB51}"/>
          </ac:picMkLst>
        </pc:picChg>
      </pc:sldChg>
      <pc:sldChg chg="modSp add mod">
        <pc:chgData name="juyoung jung" userId="2cd33e9aba789339" providerId="LiveId" clId="{AA236221-2BE9-4F5F-A09F-FD46EB557B01}" dt="2026-01-14T00:52:34.656" v="339" actId="20577"/>
        <pc:sldMkLst>
          <pc:docMk/>
          <pc:sldMk cId="3759865934" sldId="264"/>
        </pc:sldMkLst>
        <pc:spChg chg="mod">
          <ac:chgData name="juyoung jung" userId="2cd33e9aba789339" providerId="LiveId" clId="{AA236221-2BE9-4F5F-A09F-FD46EB557B01}" dt="2026-01-14T00:52:34.656" v="339" actId="20577"/>
          <ac:spMkLst>
            <pc:docMk/>
            <pc:sldMk cId="3759865934" sldId="264"/>
            <ac:spMk id="5" creationId="{D51026B7-573E-82FD-8415-7348BF55F589}"/>
          </ac:spMkLst>
        </pc:spChg>
        <pc:picChg chg="mod">
          <ac:chgData name="juyoung jung" userId="2cd33e9aba789339" providerId="LiveId" clId="{AA236221-2BE9-4F5F-A09F-FD46EB557B01}" dt="2026-01-14T00:51:01.790" v="311" actId="14826"/>
          <ac:picMkLst>
            <pc:docMk/>
            <pc:sldMk cId="3759865934" sldId="264"/>
            <ac:picMk id="8" creationId="{9882A6D3-4C85-9E0D-F27D-459F1505A6FB}"/>
          </ac:picMkLst>
        </pc:picChg>
      </pc:sldChg>
      <pc:sldChg chg="modSp add mod">
        <pc:chgData name="juyoung jung" userId="2cd33e9aba789339" providerId="LiveId" clId="{AA236221-2BE9-4F5F-A09F-FD46EB557B01}" dt="2026-01-14T00:52:37.188" v="340" actId="20577"/>
        <pc:sldMkLst>
          <pc:docMk/>
          <pc:sldMk cId="2314482421" sldId="265"/>
        </pc:sldMkLst>
        <pc:spChg chg="mod">
          <ac:chgData name="juyoung jung" userId="2cd33e9aba789339" providerId="LiveId" clId="{AA236221-2BE9-4F5F-A09F-FD46EB557B01}" dt="2026-01-14T00:52:37.188" v="340" actId="20577"/>
          <ac:spMkLst>
            <pc:docMk/>
            <pc:sldMk cId="2314482421" sldId="265"/>
            <ac:spMk id="5" creationId="{2E9F19FA-3197-45A9-1D74-E1F5CB633C58}"/>
          </ac:spMkLst>
        </pc:spChg>
        <pc:picChg chg="mod">
          <ac:chgData name="juyoung jung" userId="2cd33e9aba789339" providerId="LiveId" clId="{AA236221-2BE9-4F5F-A09F-FD46EB557B01}" dt="2026-01-14T00:51:08.902" v="312" actId="14826"/>
          <ac:picMkLst>
            <pc:docMk/>
            <pc:sldMk cId="2314482421" sldId="265"/>
            <ac:picMk id="8" creationId="{36F04604-5BB3-50DD-8CC8-E8BBB4E314B0}"/>
          </ac:picMkLst>
        </pc:picChg>
      </pc:sldChg>
      <pc:sldChg chg="modSp add mod">
        <pc:chgData name="juyoung jung" userId="2cd33e9aba789339" providerId="LiveId" clId="{AA236221-2BE9-4F5F-A09F-FD46EB557B01}" dt="2026-01-14T00:52:40.920" v="341" actId="20577"/>
        <pc:sldMkLst>
          <pc:docMk/>
          <pc:sldMk cId="1197021954" sldId="266"/>
        </pc:sldMkLst>
        <pc:spChg chg="mod">
          <ac:chgData name="juyoung jung" userId="2cd33e9aba789339" providerId="LiveId" clId="{AA236221-2BE9-4F5F-A09F-FD46EB557B01}" dt="2026-01-14T00:52:40.920" v="341" actId="20577"/>
          <ac:spMkLst>
            <pc:docMk/>
            <pc:sldMk cId="1197021954" sldId="266"/>
            <ac:spMk id="5" creationId="{8F98FFBA-BD2A-5EB4-1604-8964BC4ADDED}"/>
          </ac:spMkLst>
        </pc:spChg>
        <pc:picChg chg="mod">
          <ac:chgData name="juyoung jung" userId="2cd33e9aba789339" providerId="LiveId" clId="{AA236221-2BE9-4F5F-A09F-FD46EB557B01}" dt="2026-01-14T00:51:17.507" v="313" actId="14826"/>
          <ac:picMkLst>
            <pc:docMk/>
            <pc:sldMk cId="1197021954" sldId="266"/>
            <ac:picMk id="8" creationId="{9008D76B-8AB4-5970-17E6-A95FB91E9AB5}"/>
          </ac:picMkLst>
        </pc:picChg>
      </pc:sldChg>
      <pc:sldChg chg="modSp add mod">
        <pc:chgData name="juyoung jung" userId="2cd33e9aba789339" providerId="LiveId" clId="{AA236221-2BE9-4F5F-A09F-FD46EB557B01}" dt="2026-01-14T00:54:54.926" v="378" actId="20577"/>
        <pc:sldMkLst>
          <pc:docMk/>
          <pc:sldMk cId="3823070294" sldId="267"/>
        </pc:sldMkLst>
        <pc:spChg chg="mod">
          <ac:chgData name="juyoung jung" userId="2cd33e9aba789339" providerId="LiveId" clId="{AA236221-2BE9-4F5F-A09F-FD46EB557B01}" dt="2026-01-14T00:54:54.926" v="378" actId="20577"/>
          <ac:spMkLst>
            <pc:docMk/>
            <pc:sldMk cId="3823070294" sldId="267"/>
            <ac:spMk id="5" creationId="{E81E795B-038B-8F87-5DA7-B47756F7520B}"/>
          </ac:spMkLst>
        </pc:spChg>
        <pc:picChg chg="mod">
          <ac:chgData name="juyoung jung" userId="2cd33e9aba789339" providerId="LiveId" clId="{AA236221-2BE9-4F5F-A09F-FD46EB557B01}" dt="2026-01-14T00:53:10.794" v="351" actId="14826"/>
          <ac:picMkLst>
            <pc:docMk/>
            <pc:sldMk cId="3823070294" sldId="267"/>
            <ac:picMk id="8" creationId="{473C80CF-D04B-D5C1-6994-85D5897364EC}"/>
          </ac:picMkLst>
        </pc:picChg>
      </pc:sldChg>
      <pc:sldChg chg="modSp add mod">
        <pc:chgData name="juyoung jung" userId="2cd33e9aba789339" providerId="LiveId" clId="{AA236221-2BE9-4F5F-A09F-FD46EB557B01}" dt="2026-01-14T00:55:01.148" v="379" actId="20577"/>
        <pc:sldMkLst>
          <pc:docMk/>
          <pc:sldMk cId="1869145835" sldId="268"/>
        </pc:sldMkLst>
        <pc:spChg chg="mod">
          <ac:chgData name="juyoung jung" userId="2cd33e9aba789339" providerId="LiveId" clId="{AA236221-2BE9-4F5F-A09F-FD46EB557B01}" dt="2026-01-14T00:55:01.148" v="379" actId="20577"/>
          <ac:spMkLst>
            <pc:docMk/>
            <pc:sldMk cId="1869145835" sldId="268"/>
            <ac:spMk id="5" creationId="{1ED7B29C-D68A-48B8-5D25-68EE33C2C251}"/>
          </ac:spMkLst>
        </pc:spChg>
        <pc:picChg chg="mod">
          <ac:chgData name="juyoung jung" userId="2cd33e9aba789339" providerId="LiveId" clId="{AA236221-2BE9-4F5F-A09F-FD46EB557B01}" dt="2026-01-14T00:53:25.763" v="357" actId="14826"/>
          <ac:picMkLst>
            <pc:docMk/>
            <pc:sldMk cId="1869145835" sldId="268"/>
            <ac:picMk id="8" creationId="{5F02BED0-7CE6-DED8-8210-3215DE513060}"/>
          </ac:picMkLst>
        </pc:picChg>
      </pc:sldChg>
      <pc:sldChg chg="modSp add mod">
        <pc:chgData name="juyoung jung" userId="2cd33e9aba789339" providerId="LiveId" clId="{AA236221-2BE9-4F5F-A09F-FD46EB557B01}" dt="2026-01-14T00:55:07.261" v="380" actId="20577"/>
        <pc:sldMkLst>
          <pc:docMk/>
          <pc:sldMk cId="3468853339" sldId="269"/>
        </pc:sldMkLst>
        <pc:spChg chg="mod">
          <ac:chgData name="juyoung jung" userId="2cd33e9aba789339" providerId="LiveId" clId="{AA236221-2BE9-4F5F-A09F-FD46EB557B01}" dt="2026-01-14T00:55:07.261" v="380" actId="20577"/>
          <ac:spMkLst>
            <pc:docMk/>
            <pc:sldMk cId="3468853339" sldId="269"/>
            <ac:spMk id="5" creationId="{160100F1-A8C0-3877-78D6-E3B9FDE9E77F}"/>
          </ac:spMkLst>
        </pc:spChg>
        <pc:picChg chg="mod">
          <ac:chgData name="juyoung jung" userId="2cd33e9aba789339" providerId="LiveId" clId="{AA236221-2BE9-4F5F-A09F-FD46EB557B01}" dt="2026-01-14T00:53:35.863" v="358" actId="14826"/>
          <ac:picMkLst>
            <pc:docMk/>
            <pc:sldMk cId="3468853339" sldId="269"/>
            <ac:picMk id="8" creationId="{6CF08D45-D0E9-C282-7046-3EF99290CC6E}"/>
          </ac:picMkLst>
        </pc:picChg>
      </pc:sldChg>
      <pc:sldChg chg="modSp add mod">
        <pc:chgData name="juyoung jung" userId="2cd33e9aba789339" providerId="LiveId" clId="{AA236221-2BE9-4F5F-A09F-FD46EB557B01}" dt="2026-01-14T00:55:10.948" v="381" actId="20577"/>
        <pc:sldMkLst>
          <pc:docMk/>
          <pc:sldMk cId="2576035909" sldId="270"/>
        </pc:sldMkLst>
        <pc:spChg chg="mod">
          <ac:chgData name="juyoung jung" userId="2cd33e9aba789339" providerId="LiveId" clId="{AA236221-2BE9-4F5F-A09F-FD46EB557B01}" dt="2026-01-14T00:55:10.948" v="381" actId="20577"/>
          <ac:spMkLst>
            <pc:docMk/>
            <pc:sldMk cId="2576035909" sldId="270"/>
            <ac:spMk id="5" creationId="{18CFDD62-B395-1658-EDCA-65F5F8937FC8}"/>
          </ac:spMkLst>
        </pc:spChg>
        <pc:picChg chg="mod">
          <ac:chgData name="juyoung jung" userId="2cd33e9aba789339" providerId="LiveId" clId="{AA236221-2BE9-4F5F-A09F-FD46EB557B01}" dt="2026-01-14T00:53:43.820" v="360" actId="14826"/>
          <ac:picMkLst>
            <pc:docMk/>
            <pc:sldMk cId="2576035909" sldId="270"/>
            <ac:picMk id="8" creationId="{03F8D1D4-B280-9505-C2AE-3CF4B708B5FF}"/>
          </ac:picMkLst>
        </pc:picChg>
      </pc:sldChg>
      <pc:sldChg chg="modSp add mod">
        <pc:chgData name="juyoung jung" userId="2cd33e9aba789339" providerId="LiveId" clId="{AA236221-2BE9-4F5F-A09F-FD46EB557B01}" dt="2026-01-14T00:55:14.842" v="382" actId="20577"/>
        <pc:sldMkLst>
          <pc:docMk/>
          <pc:sldMk cId="1189430210" sldId="271"/>
        </pc:sldMkLst>
        <pc:spChg chg="mod">
          <ac:chgData name="juyoung jung" userId="2cd33e9aba789339" providerId="LiveId" clId="{AA236221-2BE9-4F5F-A09F-FD46EB557B01}" dt="2026-01-14T00:55:14.842" v="382" actId="20577"/>
          <ac:spMkLst>
            <pc:docMk/>
            <pc:sldMk cId="1189430210" sldId="271"/>
            <ac:spMk id="5" creationId="{9B5628D1-8A31-2615-2F27-38F49CC8DD1E}"/>
          </ac:spMkLst>
        </pc:spChg>
        <pc:picChg chg="mod">
          <ac:chgData name="juyoung jung" userId="2cd33e9aba789339" providerId="LiveId" clId="{AA236221-2BE9-4F5F-A09F-FD46EB557B01}" dt="2026-01-14T00:54:17.784" v="377" actId="14826"/>
          <ac:picMkLst>
            <pc:docMk/>
            <pc:sldMk cId="1189430210" sldId="271"/>
            <ac:picMk id="8" creationId="{8998FD20-FCBA-5762-2C11-F16310119EE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6FE3DB6-C877-9100-BD9B-F24AAD03CC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F4199D6-ED10-0C33-DFCB-AD8FE2053D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8623382-91CC-3891-FCF9-1F2B529468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F5A67A6-7D09-9DD4-BDD6-5923D87FB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4C0B60F-A5DA-0CD1-D6DC-6141DB531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366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12F6F60-4463-F0D1-495F-62B979C222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477DDE9-8F36-8C50-A8D9-2217623A90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7300D9F-8CC7-22EE-81AA-85445C5D6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CD8D575-D388-9ABB-353D-5EE7457DD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D39A8C-0E75-B48C-51D4-6BE3A1A74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45236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70376542-5735-4555-C72B-85B60E67A2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9473617-177C-6C11-0E26-665B7373A9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1013586-2FBB-E681-F609-F0ED4D378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287F857-7E3F-4A82-4CC6-9CFBB9DE5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A6F78B2-36A3-66E0-7AAD-6A1D476B1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00791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CBDC274-8534-1B73-CC15-21EDD0C32C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8A505BF-5A78-6EAA-BB8C-6A08BE607D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D72E146-12F5-25E2-6814-60DFF778C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A1FDE43-7192-CF5E-09B5-3B59405E1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5955A5B-EE22-1258-DFE9-EA1C233A2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12684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8408A1-EB4C-3F3E-65E1-C6764FE573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128D268-ED86-35EE-E1D3-F4868EA2C9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5B04E0F-B6DD-ABC0-433A-64FB9023C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E3DAFC-06E7-93F2-019D-63EDB5FEFC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2679330-3C76-942C-6267-BBEC7CD9E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962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7A9699-FA34-530B-22D5-607EC0252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D039C9A-B290-42DB-57F9-441F854F6B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3CD6BCC5-4C58-0219-EA1B-DB4F9FCCBC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71181D2-B457-5C7E-F65A-570B481AF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36477D7-6BC3-CEA9-049C-A6B30CC5E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C89F98A-BD32-21C9-13B3-90260D1E2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1300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9BB970-B75A-5EA4-B2B0-5F9E47D1F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2874B73-A2A0-38EF-ED61-E28B3C2FBB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4394D12-B451-4D0F-1633-ACFEDCD710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1928A3DC-C6DA-3629-8880-34C0378077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D656315-8264-3DAF-240A-3ACE6ED7727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ACF447C-33D8-6754-DB6A-4C4BDE48A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281A189-F764-4B64-74DD-692B66613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89982F4-FA93-381F-246E-F847BCA64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40352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12666A4-42B1-9F1D-5745-491A7B86CE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C658E42-B160-4F0E-5E67-AD76AC6A59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A138FF40-14C1-88D4-27F0-A63C0DA15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BEA5E01F-1C4F-3862-D40D-841942DBD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0943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F30E4A1-5E6E-C95C-104F-FC4B31EF70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746CA0E-6895-19B7-D618-64E37439AD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B50876F-09AE-8983-8066-78459A6C2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058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CEE69FD-EADC-C723-CE50-77F8D037E5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6251D6D-405B-F30E-F797-E9B65B5B5D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FC24759-C098-6F26-ED82-3946488930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ACDE452-4D26-B2CC-3F99-EECDE9777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F07BF85-6CE8-C0BD-64BD-D59B9C825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7EFD54D-D92B-B591-3DD3-785DA53AE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203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6FB1FB0-1830-B857-4777-579B9EB06C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0BE462B-A5D7-EA52-A8C9-52A28A3636F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6596CBC-E044-5E7E-43CC-144D13D974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FE278A3-F94E-C0C0-CF3A-98F32C80A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9EBE180-0C9A-034E-BD1D-1AD6865B5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DDFB1E6-CB54-01A6-EC97-4D9BECAB6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7020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EA06F52-4A01-0CE9-11B6-9BF8B0FC74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404AAA5-C9B8-8B53-CEDE-3679CA9C6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1EF9B1F-5C5B-8071-3347-A5F3E9E5F3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D22EF-FA42-48AC-AD4A-25796D8A0622}" type="datetimeFigureOut">
              <a:rPr lang="ko-KR" altLang="en-US" smtClean="0"/>
              <a:t>2026-03-24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72B9CC2-B973-0ADD-FEAD-2B357A6282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77252D-A75F-E698-CF97-85344F7847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E0CD1E-0D58-4C21-9152-0F86608D9B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49477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5A7FBCE-2A54-3CC7-FA8E-1C5A937BD4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0DEA4BF-45AA-F88C-A57C-1A0525E7F50C}"/>
              </a:ext>
            </a:extLst>
          </p:cNvPr>
          <p:cNvSpPr txBox="1"/>
          <p:nvPr/>
        </p:nvSpPr>
        <p:spPr>
          <a:xfrm>
            <a:off x="7374965" y="3224758"/>
            <a:ext cx="440250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2. (a) Kaplan-Meier curve for hypertension free survival probability in SII quartile (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82696994-8CC0-80D9-BBB1-1C0EE27312D8}"/>
              </a:ext>
            </a:extLst>
          </p:cNvPr>
          <p:cNvSpPr/>
          <p:nvPr/>
        </p:nvSpPr>
        <p:spPr>
          <a:xfrm>
            <a:off x="184834" y="568190"/>
            <a:ext cx="52770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a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690DED58-EADD-6757-357A-1B6276E5D91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28386256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6C24B3E-F825-17A8-8EF3-ACBC678398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9D2FACF-43E7-D216-C0BE-354E016255E0}"/>
              </a:ext>
            </a:extLst>
          </p:cNvPr>
          <p:cNvSpPr txBox="1"/>
          <p:nvPr/>
        </p:nvSpPr>
        <p:spPr>
          <a:xfrm>
            <a:off x="7374965" y="3224758"/>
            <a:ext cx="44665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b) Kaplan-Meier curve for hypertension free survival probability in SIRI quartile (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D0DEF1FE-B061-3F27-7D64-72E805875A59}"/>
              </a:ext>
            </a:extLst>
          </p:cNvPr>
          <p:cNvSpPr/>
          <p:nvPr/>
        </p:nvSpPr>
        <p:spPr>
          <a:xfrm>
            <a:off x="184834" y="568190"/>
            <a:ext cx="5453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b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7A9D7A01-F48C-0FD2-8BF8-263CD956AB5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5918354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2EB6054-2A25-49E9-A27B-178E88E01C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51026B7-573E-82FD-8415-7348BF55F589}"/>
              </a:ext>
            </a:extLst>
          </p:cNvPr>
          <p:cNvSpPr txBox="1"/>
          <p:nvPr/>
        </p:nvSpPr>
        <p:spPr>
          <a:xfrm>
            <a:off x="7374965" y="3224758"/>
            <a:ext cx="429277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c) Kaplan-Meier curve for hypertension free survival probability in NLR quartile (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0F834125-45F8-3B98-FED1-A1FFBCA65F4F}"/>
              </a:ext>
            </a:extLst>
          </p:cNvPr>
          <p:cNvSpPr/>
          <p:nvPr/>
        </p:nvSpPr>
        <p:spPr>
          <a:xfrm>
            <a:off x="184834" y="568190"/>
            <a:ext cx="51648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c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9882A6D3-4C85-9E0D-F27D-459F1505A6F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37598659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184556-89E2-0545-FDC6-376E6FDFD78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E9F19FA-3197-45A9-1D74-E1F5CB633C58}"/>
              </a:ext>
            </a:extLst>
          </p:cNvPr>
          <p:cNvSpPr txBox="1"/>
          <p:nvPr/>
        </p:nvSpPr>
        <p:spPr>
          <a:xfrm>
            <a:off x="7411541" y="3233903"/>
            <a:ext cx="430192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(d) Kaplan-Meier curve for hypertension free survival probability in MLR quartile (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91E19F13-E69E-E396-25B5-5EDC1EA8B18A}"/>
              </a:ext>
            </a:extLst>
          </p:cNvPr>
          <p:cNvSpPr/>
          <p:nvPr/>
        </p:nvSpPr>
        <p:spPr>
          <a:xfrm>
            <a:off x="184834" y="568190"/>
            <a:ext cx="5469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d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36F04604-5BB3-50DD-8CC8-E8BBB4E314B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23144824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3DE3214-DD87-FEE3-8610-2E089D54F69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F98FFBA-BD2A-5EB4-1604-8964BC4ADDED}"/>
              </a:ext>
            </a:extLst>
          </p:cNvPr>
          <p:cNvSpPr txBox="1"/>
          <p:nvPr/>
        </p:nvSpPr>
        <p:spPr>
          <a:xfrm>
            <a:off x="7374965" y="3224759"/>
            <a:ext cx="424706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0" lang="en-US" altLang="ko-K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terial 2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e) Kaplan-Meier curve for hypertension free survival probability in PLR quartile (Men) 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C6CD398B-EE85-84FA-985B-213F0E3C9FC3}"/>
              </a:ext>
            </a:extLst>
          </p:cNvPr>
          <p:cNvSpPr/>
          <p:nvPr/>
        </p:nvSpPr>
        <p:spPr>
          <a:xfrm>
            <a:off x="184834" y="568190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/>
              <a:t>(e) </a:t>
            </a:r>
            <a:endParaRPr lang="ko-KR" altLang="en-US" dirty="0"/>
          </a:p>
        </p:txBody>
      </p:sp>
      <p:pic>
        <p:nvPicPr>
          <p:cNvPr id="8" name="내용 개체 틀 7">
            <a:extLst>
              <a:ext uri="{FF2B5EF4-FFF2-40B4-BE49-F238E27FC236}">
                <a16:creationId xmlns:a16="http://schemas.microsoft.com/office/drawing/2014/main" id="{9008D76B-8AB4-5970-17E6-A95FB91E9AB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39976" y="63197"/>
            <a:ext cx="5921012" cy="6784197"/>
          </a:xfrm>
        </p:spPr>
      </p:pic>
    </p:spTree>
    <p:extLst>
      <p:ext uri="{BB962C8B-B14F-4D97-AF65-F5344CB8AC3E}">
        <p14:creationId xmlns:p14="http://schemas.microsoft.com/office/powerpoint/2010/main" val="11970219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115</Words>
  <Application>Microsoft Office PowerPoint</Application>
  <PresentationFormat>와이드스크린</PresentationFormat>
  <Paragraphs>10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young jung</dc:creator>
  <cp:lastModifiedBy>이제인</cp:lastModifiedBy>
  <cp:revision>9</cp:revision>
  <dcterms:created xsi:type="dcterms:W3CDTF">2023-10-04T07:58:26Z</dcterms:created>
  <dcterms:modified xsi:type="dcterms:W3CDTF">2026-03-24T05:17:47Z</dcterms:modified>
</cp:coreProperties>
</file>